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5759450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52"/>
    <p:restoredTop sz="96327"/>
  </p:normalViewPr>
  <p:slideViewPr>
    <p:cSldViewPr snapToGrid="0">
      <p:cViewPr>
        <p:scale>
          <a:sx n="113" d="100"/>
          <a:sy n="113" d="100"/>
        </p:scale>
        <p:origin x="270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59" y="1178222"/>
            <a:ext cx="4895533" cy="250642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3781306"/>
            <a:ext cx="4319588" cy="1738167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76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1068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383297"/>
            <a:ext cx="1241881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3" y="383297"/>
            <a:ext cx="3653651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161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048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1794831"/>
            <a:ext cx="4967526" cy="2994714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4817876"/>
            <a:ext cx="4967526" cy="1574849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149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1916484"/>
            <a:ext cx="2447766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1916484"/>
            <a:ext cx="2447766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529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383299"/>
            <a:ext cx="4967526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1764832"/>
            <a:ext cx="2436517" cy="864917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2629749"/>
            <a:ext cx="2436517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1764832"/>
            <a:ext cx="2448516" cy="864917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2629749"/>
            <a:ext cx="2448516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288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044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285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479954"/>
            <a:ext cx="1857573" cy="1679840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1036570"/>
            <a:ext cx="2915722" cy="5116178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2159794"/>
            <a:ext cx="1857573" cy="4001285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3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479954"/>
            <a:ext cx="1857573" cy="1679840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1036570"/>
            <a:ext cx="2915722" cy="5116178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2159794"/>
            <a:ext cx="1857573" cy="4001285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96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383299"/>
            <a:ext cx="4967526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1916484"/>
            <a:ext cx="4967526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6672698"/>
            <a:ext cx="129587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1AC11-DF9D-454A-BE70-D2FDBD73DCB8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6672698"/>
            <a:ext cx="194381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6672698"/>
            <a:ext cx="129587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338A2-F571-D247-A9A7-EC3E826BA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5586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kumimoji="1"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kumimoji="1"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kumimoji="1"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DC25B004-F91A-24F7-4A48-BD4590AECB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759450" cy="538195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886FDF-1DDC-CC1E-34CA-2422D693CD68}"/>
              </a:ext>
            </a:extLst>
          </p:cNvPr>
          <p:cNvSpPr txBox="1"/>
          <p:nvPr/>
        </p:nvSpPr>
        <p:spPr>
          <a:xfrm>
            <a:off x="0" y="5381958"/>
            <a:ext cx="575945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6. ERK5 does not have an impact on survival of GBM patients with lower stem cell properties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plan–Meier survival analysis of (A) GSC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20]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48];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6],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2]), (B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OX2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40] 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40])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-</a:t>
            </a:r>
            <a:r>
              <a:rPr lang="en-US" altLang="ja-JP" sz="10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YC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0] 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0])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M1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3] 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3])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UT4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2] 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2]), </a:t>
            </a:r>
            <a:r>
              <a:rPr lang="en-US" altLang="ja-JP" sz="10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ES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0] 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0]), and (C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OX2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 and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17])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-</a:t>
            </a:r>
            <a:r>
              <a:rPr lang="en-US" altLang="ja-JP" sz="10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YC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 and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)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M1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 and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)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UT4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 and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6]), </a:t>
            </a:r>
            <a:r>
              <a:rPr lang="en-US" altLang="ja-JP" sz="10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ES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 and ERK5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ignaling</a:t>
            </a:r>
            <a:r>
              <a:rPr lang="en-US" altLang="ja-JP" sz="1000" kern="1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ow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7]) patient groups in CGGA database.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endParaRPr kumimoji="1"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4249851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244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7</cp:revision>
  <dcterms:created xsi:type="dcterms:W3CDTF">2022-12-07T04:57:51Z</dcterms:created>
  <dcterms:modified xsi:type="dcterms:W3CDTF">2023-01-13T02:14:41Z</dcterms:modified>
</cp:coreProperties>
</file>